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747487" y="983989"/>
              <a:ext cx="4583723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70667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2083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571002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747487" y="5635697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747487" y="51511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747487" y="4666591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747487" y="4182038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747487" y="3697485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747487" y="3212932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747487" y="2728379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747487" y="2243826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747487" y="1759273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747487" y="1274720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345751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95918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9558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5612260" y="4666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336353" y="4666591"/>
              <a:ext cx="3275906" cy="0"/>
            </a:xfrm>
            <a:custGeom>
              <a:avLst/>
              <a:pathLst>
                <a:path w="3275906" h="0">
                  <a:moveTo>
                    <a:pt x="32759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336353" y="4666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5701008" y="3697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397535" y="3697485"/>
              <a:ext cx="3303472" cy="0"/>
            </a:xfrm>
            <a:custGeom>
              <a:avLst/>
              <a:pathLst>
                <a:path w="3303472" h="0">
                  <a:moveTo>
                    <a:pt x="33034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397535" y="3697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6088599" y="1274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826162" y="1274720"/>
              <a:ext cx="3262436" cy="0"/>
            </a:xfrm>
            <a:custGeom>
              <a:avLst/>
              <a:pathLst>
                <a:path w="3262436" h="0">
                  <a:moveTo>
                    <a:pt x="32624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826162" y="1274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779130" y="4182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235428" y="4182038"/>
              <a:ext cx="3543702" cy="0"/>
            </a:xfrm>
            <a:custGeom>
              <a:avLst/>
              <a:pathLst>
                <a:path w="3543702" h="0">
                  <a:moveTo>
                    <a:pt x="35437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235428" y="41820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6122859" y="1759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769483" y="1759273"/>
              <a:ext cx="3353376" cy="0"/>
            </a:xfrm>
            <a:custGeom>
              <a:avLst/>
              <a:pathLst>
                <a:path w="3353376" h="0">
                  <a:moveTo>
                    <a:pt x="33533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769483" y="1759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5919384" y="3212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495921" y="3212932"/>
              <a:ext cx="3423463" cy="0"/>
            </a:xfrm>
            <a:custGeom>
              <a:avLst/>
              <a:pathLst>
                <a:path w="3423463" h="0">
                  <a:moveTo>
                    <a:pt x="34234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495921" y="3212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5922314" y="2728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78630" y="2728379"/>
              <a:ext cx="3343684" cy="0"/>
            </a:xfrm>
            <a:custGeom>
              <a:avLst/>
              <a:pathLst>
                <a:path w="3343684" h="0">
                  <a:moveTo>
                    <a:pt x="33436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78630" y="2728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5943530" y="2243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698050" y="2243826"/>
              <a:ext cx="3245479" cy="0"/>
            </a:xfrm>
            <a:custGeom>
              <a:avLst/>
              <a:pathLst>
                <a:path w="3245479" h="0">
                  <a:moveTo>
                    <a:pt x="32454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698050" y="2243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779702" y="56356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655216" y="5635697"/>
              <a:ext cx="3124485" cy="0"/>
            </a:xfrm>
            <a:custGeom>
              <a:avLst/>
              <a:pathLst>
                <a:path w="3124485" h="0">
                  <a:moveTo>
                    <a:pt x="312448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655216" y="56356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t50"/>
            <p:cNvSpPr/>
            <p:nvPr/>
          </p:nvSpPr>
          <p:spPr>
            <a:xfrm>
              <a:off x="3949480" y="4641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t51"/>
            <p:cNvSpPr/>
            <p:nvPr/>
          </p:nvSpPr>
          <p:spPr>
            <a:xfrm>
              <a:off x="4024445" y="3672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t52"/>
            <p:cNvSpPr/>
            <p:nvPr/>
          </p:nvSpPr>
          <p:spPr>
            <a:xfrm>
              <a:off x="4432554" y="12498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t53"/>
            <p:cNvSpPr/>
            <p:nvPr/>
          </p:nvSpPr>
          <p:spPr>
            <a:xfrm>
              <a:off x="3982453" y="41572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t54"/>
            <p:cNvSpPr/>
            <p:nvPr/>
          </p:nvSpPr>
          <p:spPr>
            <a:xfrm>
              <a:off x="4421345" y="17344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t55"/>
            <p:cNvSpPr/>
            <p:nvPr/>
          </p:nvSpPr>
          <p:spPr>
            <a:xfrm>
              <a:off x="4182826" y="31881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t56"/>
            <p:cNvSpPr/>
            <p:nvPr/>
          </p:nvSpPr>
          <p:spPr>
            <a:xfrm>
              <a:off x="4225646" y="27035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t57"/>
            <p:cNvSpPr/>
            <p:nvPr/>
          </p:nvSpPr>
          <p:spPr>
            <a:xfrm>
              <a:off x="4295964" y="22190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t58"/>
            <p:cNvSpPr/>
            <p:nvPr/>
          </p:nvSpPr>
          <p:spPr>
            <a:xfrm>
              <a:off x="4192633" y="5610871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747487" y="5151144"/>
              <a:ext cx="4583723" cy="0"/>
            </a:xfrm>
            <a:custGeom>
              <a:avLst/>
              <a:pathLst>
                <a:path w="4583723" h="0">
                  <a:moveTo>
                    <a:pt x="0" y="0"/>
                  </a:moveTo>
                  <a:lnTo>
                    <a:pt x="4583723" y="0"/>
                  </a:lnTo>
                  <a:lnTo>
                    <a:pt x="4583723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tx60"/>
            <p:cNvSpPr/>
            <p:nvPr/>
          </p:nvSpPr>
          <p:spPr>
            <a:xfrm>
              <a:off x="1571946" y="5599333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62" name="tx61"/>
            <p:cNvSpPr/>
            <p:nvPr/>
          </p:nvSpPr>
          <p:spPr>
            <a:xfrm>
              <a:off x="1204688" y="462869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8608</a:t>
              </a:r>
            </a:p>
          </p:txBody>
        </p:sp>
        <p:sp>
          <p:nvSpPr>
            <p:cNvPr id="63" name="tx62"/>
            <p:cNvSpPr/>
            <p:nvPr/>
          </p:nvSpPr>
          <p:spPr>
            <a:xfrm>
              <a:off x="1148183" y="414413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90189</a:t>
              </a:r>
            </a:p>
          </p:txBody>
        </p:sp>
        <p:sp>
          <p:nvSpPr>
            <p:cNvPr id="64" name="tx63"/>
            <p:cNvSpPr/>
            <p:nvPr/>
          </p:nvSpPr>
          <p:spPr>
            <a:xfrm>
              <a:off x="1204688" y="365953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6837</a:t>
              </a:r>
            </a:p>
          </p:txBody>
        </p:sp>
        <p:sp>
          <p:nvSpPr>
            <p:cNvPr id="65" name="tx64"/>
            <p:cNvSpPr/>
            <p:nvPr/>
          </p:nvSpPr>
          <p:spPr>
            <a:xfrm>
              <a:off x="1204688" y="317498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570</a:t>
              </a:r>
            </a:p>
          </p:txBody>
        </p:sp>
        <p:sp>
          <p:nvSpPr>
            <p:cNvPr id="66" name="tx65"/>
            <p:cNvSpPr/>
            <p:nvPr/>
          </p:nvSpPr>
          <p:spPr>
            <a:xfrm>
              <a:off x="1204688" y="269042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12346</a:t>
              </a:r>
            </a:p>
          </p:txBody>
        </p:sp>
        <p:sp>
          <p:nvSpPr>
            <p:cNvPr id="67" name="tx66"/>
            <p:cNvSpPr/>
            <p:nvPr/>
          </p:nvSpPr>
          <p:spPr>
            <a:xfrm>
              <a:off x="1204688" y="22059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29295</a:t>
              </a:r>
            </a:p>
          </p:txBody>
        </p:sp>
        <p:sp>
          <p:nvSpPr>
            <p:cNvPr id="68" name="tx67"/>
            <p:cNvSpPr/>
            <p:nvPr/>
          </p:nvSpPr>
          <p:spPr>
            <a:xfrm>
              <a:off x="1204688" y="17213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6106</a:t>
              </a:r>
            </a:p>
          </p:txBody>
        </p:sp>
        <p:sp>
          <p:nvSpPr>
            <p:cNvPr id="69" name="tx68"/>
            <p:cNvSpPr/>
            <p:nvPr/>
          </p:nvSpPr>
          <p:spPr>
            <a:xfrm>
              <a:off x="1204688" y="123681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92</a:t>
              </a:r>
            </a:p>
          </p:txBody>
        </p:sp>
        <p:sp>
          <p:nvSpPr>
            <p:cNvPr id="70" name="pl69"/>
            <p:cNvSpPr/>
            <p:nvPr/>
          </p:nvSpPr>
          <p:spPr>
            <a:xfrm>
              <a:off x="1712693" y="56356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712693" y="51511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712693" y="46665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712693" y="41820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712693" y="3697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712693" y="32129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712693" y="27283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712693" y="22438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712693" y="17592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712693" y="12747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95583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345751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495918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tx82"/>
            <p:cNvSpPr/>
            <p:nvPr/>
          </p:nvSpPr>
          <p:spPr>
            <a:xfrm>
              <a:off x="1798894" y="5987367"/>
              <a:ext cx="31388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e+00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3314594" y="5987367"/>
              <a:ext cx="28583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e-04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4816268" y="5987313"/>
              <a:ext cx="285839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e-03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3130232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982816" y="6214430"/>
              <a:ext cx="6113065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idradenitis suppurativa || id:finngen_R12_L12_HIDRADENITISSUP' on 'Operation code: pilonidal sinus surgery (anal) || id:ukb-b-561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8T20:47:20Z</dcterms:modified>
  <cp:category/>
</cp:coreProperties>
</file>